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5" r:id="rId2"/>
  </p:sldIdLst>
  <p:sldSz cx="6858000" cy="9906000" type="A4"/>
  <p:notesSz cx="67833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ECEC"/>
    <a:srgbClr val="D05AD0"/>
    <a:srgbClr val="01DA02"/>
    <a:srgbClr val="BC14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498" autoAdjust="0"/>
    <p:restoredTop sz="96433" autoAdjust="0"/>
  </p:normalViewPr>
  <p:slideViewPr>
    <p:cSldViewPr snapToGrid="0">
      <p:cViewPr varScale="1">
        <p:scale>
          <a:sx n="126" d="100"/>
          <a:sy n="126" d="100"/>
        </p:scale>
        <p:origin x="2808" y="20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2350" y="0"/>
            <a:ext cx="293946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9ACCED-A51B-483E-80EA-C58192E70185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3613" y="1241425"/>
            <a:ext cx="23161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339" y="4777194"/>
            <a:ext cx="542671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2350" y="9428584"/>
            <a:ext cx="293946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18F4EB-17FA-4F5B-82DA-9E6943BA933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54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6045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7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603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447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3681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536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5418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406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086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636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653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6448A-C459-41D6-A269-2A76800D2A86}" type="datetimeFigureOut">
              <a:rPr lang="en-GB" smtClean="0"/>
              <a:t>27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B1FC1-A145-4523-9746-148EE68FA0B2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298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747550" y="7017852"/>
            <a:ext cx="2684380" cy="2508898"/>
            <a:chOff x="318182" y="6935039"/>
            <a:chExt cx="2973494" cy="2779112"/>
          </a:xfrm>
        </p:grpSpPr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6" t="62909" r="64217" b="9132"/>
            <a:stretch/>
          </p:blipFill>
          <p:spPr>
            <a:xfrm>
              <a:off x="318182" y="6935039"/>
              <a:ext cx="2519082" cy="2779112"/>
            </a:xfrm>
            <a:prstGeom prst="rect">
              <a:avLst/>
            </a:prstGeom>
          </p:spPr>
        </p:pic>
        <p:sp>
          <p:nvSpPr>
            <p:cNvPr id="39" name="Freeform 38"/>
            <p:cNvSpPr/>
            <p:nvPr/>
          </p:nvSpPr>
          <p:spPr>
            <a:xfrm>
              <a:off x="1874736" y="7067314"/>
              <a:ext cx="594685" cy="1177949"/>
            </a:xfrm>
            <a:custGeom>
              <a:avLst/>
              <a:gdLst>
                <a:gd name="connsiteX0" fmla="*/ 32078 w 860753"/>
                <a:gd name="connsiteY0" fmla="*/ 247650 h 1790700"/>
                <a:gd name="connsiteX1" fmla="*/ 41603 w 860753"/>
                <a:gd name="connsiteY1" fmla="*/ 333375 h 1790700"/>
                <a:gd name="connsiteX2" fmla="*/ 60653 w 860753"/>
                <a:gd name="connsiteY2" fmla="*/ 390525 h 1790700"/>
                <a:gd name="connsiteX3" fmla="*/ 79703 w 860753"/>
                <a:gd name="connsiteY3" fmla="*/ 504825 h 1790700"/>
                <a:gd name="connsiteX4" fmla="*/ 98753 w 860753"/>
                <a:gd name="connsiteY4" fmla="*/ 809625 h 1790700"/>
                <a:gd name="connsiteX5" fmla="*/ 117803 w 860753"/>
                <a:gd name="connsiteY5" fmla="*/ 876300 h 1790700"/>
                <a:gd name="connsiteX6" fmla="*/ 146378 w 860753"/>
                <a:gd name="connsiteY6" fmla="*/ 1009650 h 1790700"/>
                <a:gd name="connsiteX7" fmla="*/ 155903 w 860753"/>
                <a:gd name="connsiteY7" fmla="*/ 1047750 h 1790700"/>
                <a:gd name="connsiteX8" fmla="*/ 174953 w 860753"/>
                <a:gd name="connsiteY8" fmla="*/ 1076325 h 1790700"/>
                <a:gd name="connsiteX9" fmla="*/ 184478 w 860753"/>
                <a:gd name="connsiteY9" fmla="*/ 1104900 h 1790700"/>
                <a:gd name="connsiteX10" fmla="*/ 222578 w 860753"/>
                <a:gd name="connsiteY10" fmla="*/ 1162050 h 1790700"/>
                <a:gd name="connsiteX11" fmla="*/ 232103 w 860753"/>
                <a:gd name="connsiteY11" fmla="*/ 1190625 h 1790700"/>
                <a:gd name="connsiteX12" fmla="*/ 260678 w 860753"/>
                <a:gd name="connsiteY12" fmla="*/ 1257300 h 1790700"/>
                <a:gd name="connsiteX13" fmla="*/ 270203 w 860753"/>
                <a:gd name="connsiteY13" fmla="*/ 1314450 h 1790700"/>
                <a:gd name="connsiteX14" fmla="*/ 289253 w 860753"/>
                <a:gd name="connsiteY14" fmla="*/ 1504950 h 1790700"/>
                <a:gd name="connsiteX15" fmla="*/ 308303 w 860753"/>
                <a:gd name="connsiteY15" fmla="*/ 1533525 h 1790700"/>
                <a:gd name="connsiteX16" fmla="*/ 327353 w 860753"/>
                <a:gd name="connsiteY16" fmla="*/ 1571625 h 1790700"/>
                <a:gd name="connsiteX17" fmla="*/ 374978 w 860753"/>
                <a:gd name="connsiteY17" fmla="*/ 1657350 h 1790700"/>
                <a:gd name="connsiteX18" fmla="*/ 451178 w 860753"/>
                <a:gd name="connsiteY18" fmla="*/ 1676400 h 1790700"/>
                <a:gd name="connsiteX19" fmla="*/ 508328 w 860753"/>
                <a:gd name="connsiteY19" fmla="*/ 1704975 h 1790700"/>
                <a:gd name="connsiteX20" fmla="*/ 536903 w 860753"/>
                <a:gd name="connsiteY20" fmla="*/ 1714500 h 1790700"/>
                <a:gd name="connsiteX21" fmla="*/ 594053 w 860753"/>
                <a:gd name="connsiteY21" fmla="*/ 1752600 h 1790700"/>
                <a:gd name="connsiteX22" fmla="*/ 622628 w 860753"/>
                <a:gd name="connsiteY22" fmla="*/ 1781175 h 1790700"/>
                <a:gd name="connsiteX23" fmla="*/ 651203 w 860753"/>
                <a:gd name="connsiteY23" fmla="*/ 1790700 h 1790700"/>
                <a:gd name="connsiteX24" fmla="*/ 755978 w 860753"/>
                <a:gd name="connsiteY24" fmla="*/ 1724025 h 1790700"/>
                <a:gd name="connsiteX25" fmla="*/ 775028 w 860753"/>
                <a:gd name="connsiteY25" fmla="*/ 1666875 h 1790700"/>
                <a:gd name="connsiteX26" fmla="*/ 784553 w 860753"/>
                <a:gd name="connsiteY26" fmla="*/ 1638300 h 1790700"/>
                <a:gd name="connsiteX27" fmla="*/ 775028 w 860753"/>
                <a:gd name="connsiteY27" fmla="*/ 1476375 h 1790700"/>
                <a:gd name="connsiteX28" fmla="*/ 755978 w 860753"/>
                <a:gd name="connsiteY28" fmla="*/ 1409700 h 1790700"/>
                <a:gd name="connsiteX29" fmla="*/ 765503 w 860753"/>
                <a:gd name="connsiteY29" fmla="*/ 1200150 h 1790700"/>
                <a:gd name="connsiteX30" fmla="*/ 803603 w 860753"/>
                <a:gd name="connsiteY30" fmla="*/ 1104900 h 1790700"/>
                <a:gd name="connsiteX31" fmla="*/ 822653 w 860753"/>
                <a:gd name="connsiteY31" fmla="*/ 1038225 h 1790700"/>
                <a:gd name="connsiteX32" fmla="*/ 841703 w 860753"/>
                <a:gd name="connsiteY32" fmla="*/ 923925 h 1790700"/>
                <a:gd name="connsiteX33" fmla="*/ 851228 w 860753"/>
                <a:gd name="connsiteY33" fmla="*/ 609600 h 1790700"/>
                <a:gd name="connsiteX34" fmla="*/ 860753 w 860753"/>
                <a:gd name="connsiteY34" fmla="*/ 581025 h 1790700"/>
                <a:gd name="connsiteX35" fmla="*/ 851228 w 860753"/>
                <a:gd name="connsiteY35" fmla="*/ 381000 h 1790700"/>
                <a:gd name="connsiteX36" fmla="*/ 832178 w 860753"/>
                <a:gd name="connsiteY36" fmla="*/ 342900 h 1790700"/>
                <a:gd name="connsiteX37" fmla="*/ 822653 w 860753"/>
                <a:gd name="connsiteY37" fmla="*/ 304800 h 1790700"/>
                <a:gd name="connsiteX38" fmla="*/ 794078 w 860753"/>
                <a:gd name="connsiteY38" fmla="*/ 219075 h 1790700"/>
                <a:gd name="connsiteX39" fmla="*/ 784553 w 860753"/>
                <a:gd name="connsiteY39" fmla="*/ 190500 h 1790700"/>
                <a:gd name="connsiteX40" fmla="*/ 736928 w 860753"/>
                <a:gd name="connsiteY40" fmla="*/ 104775 h 1790700"/>
                <a:gd name="connsiteX41" fmla="*/ 708353 w 860753"/>
                <a:gd name="connsiteY41" fmla="*/ 85725 h 1790700"/>
                <a:gd name="connsiteX42" fmla="*/ 651203 w 860753"/>
                <a:gd name="connsiteY42" fmla="*/ 66675 h 1790700"/>
                <a:gd name="connsiteX43" fmla="*/ 622628 w 860753"/>
                <a:gd name="connsiteY43" fmla="*/ 57150 h 1790700"/>
                <a:gd name="connsiteX44" fmla="*/ 584528 w 860753"/>
                <a:gd name="connsiteY44" fmla="*/ 38100 h 1790700"/>
                <a:gd name="connsiteX45" fmla="*/ 517853 w 860753"/>
                <a:gd name="connsiteY45" fmla="*/ 19050 h 1790700"/>
                <a:gd name="connsiteX46" fmla="*/ 384503 w 860753"/>
                <a:gd name="connsiteY46" fmla="*/ 0 h 1790700"/>
                <a:gd name="connsiteX47" fmla="*/ 165428 w 860753"/>
                <a:gd name="connsiteY47" fmla="*/ 9525 h 1790700"/>
                <a:gd name="connsiteX48" fmla="*/ 108278 w 860753"/>
                <a:gd name="connsiteY48" fmla="*/ 38100 h 1790700"/>
                <a:gd name="connsiteX49" fmla="*/ 79703 w 860753"/>
                <a:gd name="connsiteY49" fmla="*/ 47625 h 1790700"/>
                <a:gd name="connsiteX50" fmla="*/ 60653 w 860753"/>
                <a:gd name="connsiteY50" fmla="*/ 76200 h 1790700"/>
                <a:gd name="connsiteX51" fmla="*/ 32078 w 860753"/>
                <a:gd name="connsiteY51" fmla="*/ 95250 h 1790700"/>
                <a:gd name="connsiteX52" fmla="*/ 3503 w 860753"/>
                <a:gd name="connsiteY52" fmla="*/ 123825 h 1790700"/>
                <a:gd name="connsiteX53" fmla="*/ 32078 w 860753"/>
                <a:gd name="connsiteY53" fmla="*/ 247650 h 1790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</a:cxnLst>
              <a:rect l="l" t="t" r="r" b="b"/>
              <a:pathLst>
                <a:path w="860753" h="1790700">
                  <a:moveTo>
                    <a:pt x="32078" y="247650"/>
                  </a:moveTo>
                  <a:cubicBezTo>
                    <a:pt x="38428" y="282575"/>
                    <a:pt x="35964" y="305182"/>
                    <a:pt x="41603" y="333375"/>
                  </a:cubicBezTo>
                  <a:cubicBezTo>
                    <a:pt x="45541" y="353066"/>
                    <a:pt x="56715" y="370834"/>
                    <a:pt x="60653" y="390525"/>
                  </a:cubicBezTo>
                  <a:cubicBezTo>
                    <a:pt x="74581" y="460165"/>
                    <a:pt x="67888" y="422123"/>
                    <a:pt x="79703" y="504825"/>
                  </a:cubicBezTo>
                  <a:cubicBezTo>
                    <a:pt x="82367" y="574099"/>
                    <a:pt x="77424" y="717200"/>
                    <a:pt x="98753" y="809625"/>
                  </a:cubicBezTo>
                  <a:cubicBezTo>
                    <a:pt x="103950" y="832147"/>
                    <a:pt x="111453" y="854075"/>
                    <a:pt x="117803" y="876300"/>
                  </a:cubicBezTo>
                  <a:cubicBezTo>
                    <a:pt x="138469" y="1041631"/>
                    <a:pt x="112447" y="873927"/>
                    <a:pt x="146378" y="1009650"/>
                  </a:cubicBezTo>
                  <a:cubicBezTo>
                    <a:pt x="149553" y="1022350"/>
                    <a:pt x="150746" y="1035718"/>
                    <a:pt x="155903" y="1047750"/>
                  </a:cubicBezTo>
                  <a:cubicBezTo>
                    <a:pt x="160412" y="1058272"/>
                    <a:pt x="169833" y="1066086"/>
                    <a:pt x="174953" y="1076325"/>
                  </a:cubicBezTo>
                  <a:cubicBezTo>
                    <a:pt x="179443" y="1085305"/>
                    <a:pt x="179602" y="1096123"/>
                    <a:pt x="184478" y="1104900"/>
                  </a:cubicBezTo>
                  <a:cubicBezTo>
                    <a:pt x="195597" y="1124914"/>
                    <a:pt x="215338" y="1140330"/>
                    <a:pt x="222578" y="1162050"/>
                  </a:cubicBezTo>
                  <a:cubicBezTo>
                    <a:pt x="225753" y="1171575"/>
                    <a:pt x="228148" y="1181397"/>
                    <a:pt x="232103" y="1190625"/>
                  </a:cubicBezTo>
                  <a:cubicBezTo>
                    <a:pt x="245543" y="1221985"/>
                    <a:pt x="253805" y="1226371"/>
                    <a:pt x="260678" y="1257300"/>
                  </a:cubicBezTo>
                  <a:cubicBezTo>
                    <a:pt x="264868" y="1276153"/>
                    <a:pt x="267028" y="1295400"/>
                    <a:pt x="270203" y="1314450"/>
                  </a:cubicBezTo>
                  <a:cubicBezTo>
                    <a:pt x="270271" y="1315467"/>
                    <a:pt x="273940" y="1464116"/>
                    <a:pt x="289253" y="1504950"/>
                  </a:cubicBezTo>
                  <a:cubicBezTo>
                    <a:pt x="293273" y="1515669"/>
                    <a:pt x="302623" y="1523586"/>
                    <a:pt x="308303" y="1533525"/>
                  </a:cubicBezTo>
                  <a:cubicBezTo>
                    <a:pt x="315348" y="1545853"/>
                    <a:pt x="322080" y="1558442"/>
                    <a:pt x="327353" y="1571625"/>
                  </a:cubicBezTo>
                  <a:cubicBezTo>
                    <a:pt x="345426" y="1616809"/>
                    <a:pt x="335717" y="1631176"/>
                    <a:pt x="374978" y="1657350"/>
                  </a:cubicBezTo>
                  <a:cubicBezTo>
                    <a:pt x="388042" y="1666059"/>
                    <a:pt x="443484" y="1674476"/>
                    <a:pt x="451178" y="1676400"/>
                  </a:cubicBezTo>
                  <a:cubicBezTo>
                    <a:pt x="499061" y="1688371"/>
                    <a:pt x="461767" y="1681695"/>
                    <a:pt x="508328" y="1704975"/>
                  </a:cubicBezTo>
                  <a:cubicBezTo>
                    <a:pt x="517308" y="1709465"/>
                    <a:pt x="528126" y="1709624"/>
                    <a:pt x="536903" y="1714500"/>
                  </a:cubicBezTo>
                  <a:cubicBezTo>
                    <a:pt x="556917" y="1725619"/>
                    <a:pt x="577864" y="1736411"/>
                    <a:pt x="594053" y="1752600"/>
                  </a:cubicBezTo>
                  <a:cubicBezTo>
                    <a:pt x="603578" y="1762125"/>
                    <a:pt x="611420" y="1773703"/>
                    <a:pt x="622628" y="1781175"/>
                  </a:cubicBezTo>
                  <a:cubicBezTo>
                    <a:pt x="630982" y="1786744"/>
                    <a:pt x="641678" y="1787525"/>
                    <a:pt x="651203" y="1790700"/>
                  </a:cubicBezTo>
                  <a:cubicBezTo>
                    <a:pt x="714518" y="1781655"/>
                    <a:pt x="731965" y="1796064"/>
                    <a:pt x="755978" y="1724025"/>
                  </a:cubicBezTo>
                  <a:lnTo>
                    <a:pt x="775028" y="1666875"/>
                  </a:lnTo>
                  <a:lnTo>
                    <a:pt x="784553" y="1638300"/>
                  </a:lnTo>
                  <a:cubicBezTo>
                    <a:pt x="781378" y="1584325"/>
                    <a:pt x="780154" y="1530200"/>
                    <a:pt x="775028" y="1476375"/>
                  </a:cubicBezTo>
                  <a:cubicBezTo>
                    <a:pt x="773433" y="1459631"/>
                    <a:pt x="761693" y="1426844"/>
                    <a:pt x="755978" y="1409700"/>
                  </a:cubicBezTo>
                  <a:cubicBezTo>
                    <a:pt x="759153" y="1339850"/>
                    <a:pt x="758054" y="1269674"/>
                    <a:pt x="765503" y="1200150"/>
                  </a:cubicBezTo>
                  <a:cubicBezTo>
                    <a:pt x="769633" y="1161607"/>
                    <a:pt x="789298" y="1138278"/>
                    <a:pt x="803603" y="1104900"/>
                  </a:cubicBezTo>
                  <a:cubicBezTo>
                    <a:pt x="810946" y="1087766"/>
                    <a:pt x="818935" y="1054956"/>
                    <a:pt x="822653" y="1038225"/>
                  </a:cubicBezTo>
                  <a:cubicBezTo>
                    <a:pt x="833795" y="988084"/>
                    <a:pt x="833751" y="979586"/>
                    <a:pt x="841703" y="923925"/>
                  </a:cubicBezTo>
                  <a:cubicBezTo>
                    <a:pt x="844878" y="819150"/>
                    <a:pt x="845413" y="714262"/>
                    <a:pt x="851228" y="609600"/>
                  </a:cubicBezTo>
                  <a:cubicBezTo>
                    <a:pt x="851785" y="599575"/>
                    <a:pt x="860753" y="591065"/>
                    <a:pt x="860753" y="581025"/>
                  </a:cubicBezTo>
                  <a:cubicBezTo>
                    <a:pt x="860753" y="514274"/>
                    <a:pt x="859181" y="447275"/>
                    <a:pt x="851228" y="381000"/>
                  </a:cubicBezTo>
                  <a:cubicBezTo>
                    <a:pt x="849536" y="366902"/>
                    <a:pt x="837164" y="356195"/>
                    <a:pt x="832178" y="342900"/>
                  </a:cubicBezTo>
                  <a:cubicBezTo>
                    <a:pt x="827581" y="330643"/>
                    <a:pt x="826415" y="317339"/>
                    <a:pt x="822653" y="304800"/>
                  </a:cubicBezTo>
                  <a:lnTo>
                    <a:pt x="794078" y="219075"/>
                  </a:lnTo>
                  <a:lnTo>
                    <a:pt x="784553" y="190500"/>
                  </a:lnTo>
                  <a:cubicBezTo>
                    <a:pt x="774627" y="160723"/>
                    <a:pt x="765001" y="123490"/>
                    <a:pt x="736928" y="104775"/>
                  </a:cubicBezTo>
                  <a:cubicBezTo>
                    <a:pt x="727403" y="98425"/>
                    <a:pt x="718814" y="90374"/>
                    <a:pt x="708353" y="85725"/>
                  </a:cubicBezTo>
                  <a:cubicBezTo>
                    <a:pt x="690003" y="77570"/>
                    <a:pt x="670253" y="73025"/>
                    <a:pt x="651203" y="66675"/>
                  </a:cubicBezTo>
                  <a:cubicBezTo>
                    <a:pt x="641678" y="63500"/>
                    <a:pt x="631608" y="61640"/>
                    <a:pt x="622628" y="57150"/>
                  </a:cubicBezTo>
                  <a:cubicBezTo>
                    <a:pt x="609928" y="50800"/>
                    <a:pt x="597579" y="43693"/>
                    <a:pt x="584528" y="38100"/>
                  </a:cubicBezTo>
                  <a:cubicBezTo>
                    <a:pt x="570587" y="32125"/>
                    <a:pt x="530420" y="20983"/>
                    <a:pt x="517853" y="19050"/>
                  </a:cubicBezTo>
                  <a:cubicBezTo>
                    <a:pt x="321764" y="-11118"/>
                    <a:pt x="513405" y="25780"/>
                    <a:pt x="384503" y="0"/>
                  </a:cubicBezTo>
                  <a:cubicBezTo>
                    <a:pt x="311478" y="3175"/>
                    <a:pt x="238307" y="3919"/>
                    <a:pt x="165428" y="9525"/>
                  </a:cubicBezTo>
                  <a:cubicBezTo>
                    <a:pt x="137134" y="11701"/>
                    <a:pt x="132504" y="25987"/>
                    <a:pt x="108278" y="38100"/>
                  </a:cubicBezTo>
                  <a:cubicBezTo>
                    <a:pt x="99298" y="42590"/>
                    <a:pt x="89228" y="44450"/>
                    <a:pt x="79703" y="47625"/>
                  </a:cubicBezTo>
                  <a:cubicBezTo>
                    <a:pt x="73353" y="57150"/>
                    <a:pt x="68748" y="68105"/>
                    <a:pt x="60653" y="76200"/>
                  </a:cubicBezTo>
                  <a:cubicBezTo>
                    <a:pt x="52558" y="84295"/>
                    <a:pt x="40872" y="87921"/>
                    <a:pt x="32078" y="95250"/>
                  </a:cubicBezTo>
                  <a:cubicBezTo>
                    <a:pt x="21730" y="103874"/>
                    <a:pt x="13028" y="114300"/>
                    <a:pt x="3503" y="123825"/>
                  </a:cubicBezTo>
                  <a:cubicBezTo>
                    <a:pt x="-11412" y="183486"/>
                    <a:pt x="25728" y="212725"/>
                    <a:pt x="32078" y="247650"/>
                  </a:cubicBezTo>
                  <a:close/>
                </a:path>
              </a:pathLst>
            </a:custGeom>
            <a:noFill/>
            <a:ln w="19050"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flipH="1">
              <a:off x="2408929" y="7310047"/>
              <a:ext cx="8827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Proliferating CAFs -1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335331" y="8045208"/>
              <a:ext cx="90321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Proliferating CAFs -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00" t="61175" r="15360" b="7822"/>
          <a:stretch/>
        </p:blipFill>
        <p:spPr>
          <a:xfrm>
            <a:off x="3613168" y="6776258"/>
            <a:ext cx="3080290" cy="2991397"/>
          </a:xfrm>
          <a:prstGeom prst="rect">
            <a:avLst/>
          </a:prstGeom>
        </p:spPr>
      </p:pic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56D93FE3-785B-E824-A6FA-816E75963A51}"/>
              </a:ext>
            </a:extLst>
          </p:cNvPr>
          <p:cNvGrpSpPr/>
          <p:nvPr/>
        </p:nvGrpSpPr>
        <p:grpSpPr>
          <a:xfrm>
            <a:off x="203200" y="311252"/>
            <a:ext cx="2842337" cy="3032673"/>
            <a:chOff x="203200" y="114300"/>
            <a:chExt cx="2842337" cy="3032673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9186" y="435406"/>
              <a:ext cx="2606351" cy="2711567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203200" y="114300"/>
              <a:ext cx="21226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 Figure </a:t>
              </a:r>
              <a:r>
                <a:rPr lang="de-DE" dirty="0"/>
                <a:t>3</a:t>
              </a:r>
              <a:endParaRPr lang="en-GB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98684" y="414964"/>
              <a:ext cx="2945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12CAF723-7551-EB9F-5646-17175052CF65}"/>
              </a:ext>
            </a:extLst>
          </p:cNvPr>
          <p:cNvGrpSpPr/>
          <p:nvPr/>
        </p:nvGrpSpPr>
        <p:grpSpPr>
          <a:xfrm>
            <a:off x="611412" y="3516850"/>
            <a:ext cx="6436291" cy="2987674"/>
            <a:chOff x="611412" y="3432442"/>
            <a:chExt cx="6436291" cy="2987674"/>
          </a:xfrm>
        </p:grpSpPr>
        <p:grpSp>
          <p:nvGrpSpPr>
            <p:cNvPr id="47" name="Group 46"/>
            <p:cNvGrpSpPr/>
            <p:nvPr/>
          </p:nvGrpSpPr>
          <p:grpSpPr>
            <a:xfrm>
              <a:off x="2283112" y="4974028"/>
              <a:ext cx="1455322" cy="1405786"/>
              <a:chOff x="682031" y="7470161"/>
              <a:chExt cx="1455322" cy="1405786"/>
            </a:xfrm>
          </p:grpSpPr>
          <p:pic>
            <p:nvPicPr>
              <p:cNvPr id="48" name="Picture 47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74" r="12782" b="8577"/>
              <a:stretch/>
            </p:blipFill>
            <p:spPr>
              <a:xfrm>
                <a:off x="710492" y="7705593"/>
                <a:ext cx="1209675" cy="1170354"/>
              </a:xfrm>
              <a:prstGeom prst="rect">
                <a:avLst/>
              </a:prstGeom>
            </p:spPr>
          </p:pic>
          <p:sp>
            <p:nvSpPr>
              <p:cNvPr id="49" name="TextBox 48"/>
              <p:cNvSpPr txBox="1"/>
              <p:nvPr/>
            </p:nvSpPr>
            <p:spPr>
              <a:xfrm>
                <a:off x="1110728" y="7651210"/>
                <a:ext cx="4828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gs5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682031" y="7470161"/>
                <a:ext cx="1455322" cy="246221"/>
              </a:xfrm>
              <a:prstGeom prst="rect">
                <a:avLst/>
              </a:prstGeom>
              <a:noFill/>
              <a:ln>
                <a:noFill/>
                <a:prstDash val="lgDashDotDot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0066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mooth muscle cells</a:t>
                </a:r>
                <a:endParaRPr lang="en-GB" sz="1000" dirty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5395261" y="5490990"/>
              <a:ext cx="426720" cy="929126"/>
              <a:chOff x="4979172" y="8635616"/>
              <a:chExt cx="426720" cy="929126"/>
            </a:xfrm>
          </p:grpSpPr>
          <p:pic>
            <p:nvPicPr>
              <p:cNvPr id="52" name="Picture 51"/>
              <p:cNvPicPr>
                <a:picLocks noChangeAspect="1"/>
              </p:cNvPicPr>
              <p:nvPr/>
            </p:nvPicPr>
            <p:blipFill rotWithShape="1">
              <a:blip r:embed="rId6"/>
              <a:srcRect l="92263" r="-158" b="9238"/>
              <a:stretch/>
            </p:blipFill>
            <p:spPr>
              <a:xfrm>
                <a:off x="5063057" y="8785860"/>
                <a:ext cx="254761" cy="589698"/>
              </a:xfrm>
              <a:prstGeom prst="rect">
                <a:avLst/>
              </a:prstGeom>
            </p:spPr>
          </p:pic>
          <p:sp>
            <p:nvSpPr>
              <p:cNvPr id="53" name="TextBox 52"/>
              <p:cNvSpPr txBox="1"/>
              <p:nvPr/>
            </p:nvSpPr>
            <p:spPr>
              <a:xfrm>
                <a:off x="5002613" y="9318521"/>
                <a:ext cx="39145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n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4979172" y="8635616"/>
                <a:ext cx="4267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ax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3959820" y="5042557"/>
              <a:ext cx="1417620" cy="1367109"/>
              <a:chOff x="4355680" y="7447301"/>
              <a:chExt cx="1417620" cy="1367109"/>
            </a:xfrm>
          </p:grpSpPr>
          <p:pic>
            <p:nvPicPr>
              <p:cNvPr id="56" name="Picture 55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31" r="11802" b="8924"/>
              <a:stretch/>
            </p:blipFill>
            <p:spPr>
              <a:xfrm>
                <a:off x="4369853" y="7648493"/>
                <a:ext cx="1223962" cy="1165917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4765170" y="7631269"/>
                <a:ext cx="4683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nxb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4355680" y="7447301"/>
                <a:ext cx="1417620" cy="246221"/>
              </a:xfrm>
              <a:prstGeom prst="rect">
                <a:avLst/>
              </a:prstGeom>
              <a:noFill/>
              <a:ln>
                <a:noFill/>
                <a:prstDash val="lg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CM fibroblasts</a:t>
                </a:r>
                <a:endParaRPr lang="en-GB" sz="1000" dirty="0">
                  <a:solidFill>
                    <a:srgbClr val="CC00C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" name="Group 58"/>
            <p:cNvGrpSpPr/>
            <p:nvPr/>
          </p:nvGrpSpPr>
          <p:grpSpPr>
            <a:xfrm>
              <a:off x="611412" y="5006301"/>
              <a:ext cx="1831346" cy="1413815"/>
              <a:chOff x="4114642" y="5770067"/>
              <a:chExt cx="1831346" cy="1413815"/>
            </a:xfrm>
          </p:grpSpPr>
          <p:pic>
            <p:nvPicPr>
              <p:cNvPr id="60" name="Picture 59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2" r="12309" b="7574"/>
              <a:stretch/>
            </p:blipFill>
            <p:spPr>
              <a:xfrm>
                <a:off x="4369559" y="6000683"/>
                <a:ext cx="1219201" cy="1183199"/>
              </a:xfrm>
              <a:prstGeom prst="rect">
                <a:avLst/>
              </a:prstGeom>
            </p:spPr>
          </p:pic>
          <p:sp>
            <p:nvSpPr>
              <p:cNvPr id="61" name="TextBox 60"/>
              <p:cNvSpPr txBox="1"/>
              <p:nvPr/>
            </p:nvSpPr>
            <p:spPr>
              <a:xfrm>
                <a:off x="4793561" y="5934050"/>
                <a:ext cx="4395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i16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4114642" y="5770067"/>
                <a:ext cx="1831346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dvential fibroblasts</a:t>
                </a:r>
                <a:endParaRPr lang="en-GB" sz="1000" dirty="0">
                  <a:solidFill>
                    <a:srgbClr val="0099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3641525" y="3472654"/>
              <a:ext cx="1975148" cy="1378611"/>
              <a:chOff x="2189988" y="7447301"/>
              <a:chExt cx="1975148" cy="1378611"/>
            </a:xfrm>
          </p:grpSpPr>
          <p:pic>
            <p:nvPicPr>
              <p:cNvPr id="64" name="Picture 63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00" r="12871" b="8309"/>
              <a:stretch/>
            </p:blipFill>
            <p:spPr>
              <a:xfrm>
                <a:off x="2551575" y="7652118"/>
                <a:ext cx="1200151" cy="1173794"/>
              </a:xfrm>
              <a:prstGeom prst="rect">
                <a:avLst/>
              </a:prstGeom>
            </p:spPr>
          </p:pic>
          <p:sp>
            <p:nvSpPr>
              <p:cNvPr id="65" name="TextBox 64"/>
              <p:cNvSpPr txBox="1"/>
              <p:nvPr/>
            </p:nvSpPr>
            <p:spPr>
              <a:xfrm>
                <a:off x="2939549" y="7629635"/>
                <a:ext cx="47481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bn2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2189988" y="7447301"/>
                <a:ext cx="1975148" cy="246221"/>
              </a:xfrm>
              <a:prstGeom prst="rect">
                <a:avLst/>
              </a:prstGeom>
              <a:noFill/>
              <a:ln>
                <a:noFill/>
                <a:prstDash val="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99CC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renchymal fibroblasts</a:t>
                </a:r>
                <a:endParaRPr lang="en-GB" sz="1000" dirty="0">
                  <a:solidFill>
                    <a:srgbClr val="99CC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7" name="Group 66"/>
            <p:cNvGrpSpPr/>
            <p:nvPr/>
          </p:nvGrpSpPr>
          <p:grpSpPr>
            <a:xfrm>
              <a:off x="5184650" y="3528408"/>
              <a:ext cx="1863053" cy="1369086"/>
              <a:chOff x="460651" y="4411573"/>
              <a:chExt cx="1863053" cy="1369086"/>
            </a:xfrm>
          </p:grpSpPr>
          <p:pic>
            <p:nvPicPr>
              <p:cNvPr id="68" name="Picture 67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51" r="11867" b="8554"/>
              <a:stretch/>
            </p:blipFill>
            <p:spPr>
              <a:xfrm>
                <a:off x="700859" y="4609998"/>
                <a:ext cx="1233489" cy="1170661"/>
              </a:xfrm>
              <a:prstGeom prst="rect">
                <a:avLst/>
              </a:prstGeom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1104487" y="4586638"/>
                <a:ext cx="51648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egfa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460651" y="4411573"/>
                <a:ext cx="1863053" cy="246221"/>
              </a:xfrm>
              <a:prstGeom prst="rect">
                <a:avLst/>
              </a:prstGeom>
              <a:noFill/>
              <a:ln>
                <a:noFill/>
                <a:prstDash val="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66CC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EGF</a:t>
                </a:r>
                <a:r>
                  <a:rPr lang="el-GR" sz="1000" dirty="0">
                    <a:solidFill>
                      <a:srgbClr val="66CC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de-DE" sz="1000" dirty="0">
                    <a:solidFill>
                      <a:srgbClr val="66CC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AFs</a:t>
                </a:r>
                <a:endParaRPr lang="en-GB" sz="1000" dirty="0">
                  <a:solidFill>
                    <a:srgbClr val="66CC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" name="Group 70"/>
            <p:cNvGrpSpPr/>
            <p:nvPr/>
          </p:nvGrpSpPr>
          <p:grpSpPr>
            <a:xfrm>
              <a:off x="2215176" y="3450497"/>
              <a:ext cx="1642997" cy="1439944"/>
              <a:chOff x="6013742" y="6382035"/>
              <a:chExt cx="1642997" cy="1439944"/>
            </a:xfrm>
          </p:grpSpPr>
          <p:pic>
            <p:nvPicPr>
              <p:cNvPr id="72" name="Picture 71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33" r="12208" b="7530"/>
              <a:stretch/>
            </p:blipFill>
            <p:spPr>
              <a:xfrm>
                <a:off x="6142681" y="6638218"/>
                <a:ext cx="1219200" cy="1183761"/>
              </a:xfrm>
              <a:prstGeom prst="rect">
                <a:avLst/>
              </a:prstGeom>
            </p:spPr>
          </p:pic>
          <p:sp>
            <p:nvSpPr>
              <p:cNvPr id="73" name="TextBox 72"/>
              <p:cNvSpPr txBox="1"/>
              <p:nvPr/>
            </p:nvSpPr>
            <p:spPr>
              <a:xfrm>
                <a:off x="6553073" y="6567844"/>
                <a:ext cx="4475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hip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013742" y="6382035"/>
                <a:ext cx="1642997" cy="246221"/>
              </a:xfrm>
              <a:prstGeom prst="rect">
                <a:avLst/>
              </a:prstGeom>
              <a:noFill/>
              <a:ln>
                <a:noFill/>
                <a:prstDash val="lg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eribronchial fibroblasts</a:t>
                </a:r>
                <a:endParaRPr lang="en-GB" sz="1000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5" name="Group 74"/>
            <p:cNvGrpSpPr/>
            <p:nvPr/>
          </p:nvGrpSpPr>
          <p:grpSpPr>
            <a:xfrm>
              <a:off x="801821" y="3432442"/>
              <a:ext cx="1513227" cy="1418823"/>
              <a:chOff x="4060853" y="6359312"/>
              <a:chExt cx="1513227" cy="1418823"/>
            </a:xfrm>
          </p:grpSpPr>
          <p:pic>
            <p:nvPicPr>
              <p:cNvPr id="76" name="Picture 75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89" r="11743" b="8244"/>
              <a:stretch/>
            </p:blipFill>
            <p:spPr>
              <a:xfrm>
                <a:off x="4156779" y="6603513"/>
                <a:ext cx="1223962" cy="1174622"/>
              </a:xfrm>
              <a:prstGeom prst="rect">
                <a:avLst/>
              </a:prstGeom>
            </p:spPr>
          </p:pic>
          <p:sp>
            <p:nvSpPr>
              <p:cNvPr id="77" name="TextBox 76"/>
              <p:cNvSpPr txBox="1"/>
              <p:nvPr/>
            </p:nvSpPr>
            <p:spPr>
              <a:xfrm>
                <a:off x="4588508" y="6542037"/>
                <a:ext cx="4539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pnt</a:t>
                </a:r>
                <a:endParaRPr lang="en-GB" sz="10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4060853" y="6359312"/>
                <a:ext cx="1513227" cy="246221"/>
              </a:xfrm>
              <a:prstGeom prst="rect">
                <a:avLst/>
              </a:prstGeom>
              <a:noFill/>
              <a:ln>
                <a:noFill/>
                <a:prstDash val="lgDash"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veolar fibroblasts</a:t>
                </a:r>
                <a:endParaRPr lang="en-GB" sz="100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0" name="TextBox 79"/>
            <p:cNvSpPr txBox="1"/>
            <p:nvPr/>
          </p:nvSpPr>
          <p:spPr>
            <a:xfrm>
              <a:off x="618566" y="3465449"/>
              <a:ext cx="2945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" name="TextBox 80"/>
          <p:cNvSpPr txBox="1"/>
          <p:nvPr/>
        </p:nvSpPr>
        <p:spPr>
          <a:xfrm>
            <a:off x="608918" y="7006705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718212" y="7012304"/>
            <a:ext cx="294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</Words>
  <Application>Microsoft Macintosh PowerPoint</Application>
  <PresentationFormat>A4-Papier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uch, Saskia</dc:creator>
  <cp:lastModifiedBy>Peter Angel</cp:lastModifiedBy>
  <cp:revision>224</cp:revision>
  <cp:lastPrinted>2024-01-12T09:55:11Z</cp:lastPrinted>
  <dcterms:created xsi:type="dcterms:W3CDTF">2023-06-21T13:26:00Z</dcterms:created>
  <dcterms:modified xsi:type="dcterms:W3CDTF">2024-11-27T13:26:41Z</dcterms:modified>
</cp:coreProperties>
</file>